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63" r:id="rId3"/>
    <p:sldId id="266" r:id="rId4"/>
    <p:sldId id="267" r:id="rId5"/>
    <p:sldId id="265" r:id="rId6"/>
    <p:sldId id="268" r:id="rId7"/>
  </p:sldIdLst>
  <p:sldSz cx="11522075" cy="144018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Objects="1">
      <p:cViewPr>
        <p:scale>
          <a:sx n="28" d="100"/>
          <a:sy n="28" d="100"/>
        </p:scale>
        <p:origin x="-2076" y="-48"/>
      </p:cViewPr>
      <p:guideLst>
        <p:guide orient="horz" pos="4536"/>
        <p:guide pos="363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bar"/>
        <c:grouping val="stacked"/>
        <c:varyColors val="0"/>
        <c:ser>
          <c:idx val="0"/>
          <c:order val="0"/>
          <c:tx>
            <c:strRef>
              <c:f>fpkm_anno!$J$13</c:f>
              <c:strCache>
                <c:ptCount val="1"/>
                <c:pt idx="0">
                  <c:v>expresion of STK11 gene</c:v>
                </c:pt>
              </c:strCache>
            </c:strRef>
          </c:tx>
          <c:invertIfNegative val="0"/>
          <c:cat>
            <c:strRef>
              <c:f>fpkm_anno!$K$12:$AB$12</c:f>
              <c:strCache>
                <c:ptCount val="18"/>
                <c:pt idx="0">
                  <c:v>(p.C132W)PJS 1</c:v>
                </c:pt>
                <c:pt idx="1">
                  <c:v>(Het del exon  1)PJS 2</c:v>
                </c:pt>
                <c:pt idx="2">
                  <c:v>(Het del exon 2-3)PJS 3</c:v>
                </c:pt>
                <c:pt idx="3">
                  <c:v>(p.W308*)PJS 4</c:v>
                </c:pt>
                <c:pt idx="4">
                  <c:v>(p.P281Rfs*6)PJS 5</c:v>
                </c:pt>
                <c:pt idx="5">
                  <c:v>(p.V143Gfs*18)PJS 6</c:v>
                </c:pt>
                <c:pt idx="6">
                  <c:v>Control A-1</c:v>
                </c:pt>
                <c:pt idx="7">
                  <c:v>Control A-2</c:v>
                </c:pt>
                <c:pt idx="8">
                  <c:v>Control A-3</c:v>
                </c:pt>
                <c:pt idx="9">
                  <c:v>Control A-4</c:v>
                </c:pt>
                <c:pt idx="10">
                  <c:v>Control A-5</c:v>
                </c:pt>
                <c:pt idx="11">
                  <c:v>Control A-6</c:v>
                </c:pt>
                <c:pt idx="12">
                  <c:v>Control B-1</c:v>
                </c:pt>
                <c:pt idx="13">
                  <c:v>Control B-2</c:v>
                </c:pt>
                <c:pt idx="14">
                  <c:v>Control B-3</c:v>
                </c:pt>
                <c:pt idx="15">
                  <c:v>Control B-4</c:v>
                </c:pt>
                <c:pt idx="16">
                  <c:v>Control B-5</c:v>
                </c:pt>
                <c:pt idx="17">
                  <c:v>Control B-6</c:v>
                </c:pt>
              </c:strCache>
            </c:strRef>
          </c:cat>
          <c:val>
            <c:numRef>
              <c:f>fpkm_anno!$K$13:$AB$13</c:f>
              <c:numCache>
                <c:formatCode>General</c:formatCode>
                <c:ptCount val="18"/>
                <c:pt idx="0">
                  <c:v>20.154499999999999</c:v>
                </c:pt>
                <c:pt idx="1">
                  <c:v>4.7499099999999999</c:v>
                </c:pt>
                <c:pt idx="2">
                  <c:v>12.0349</c:v>
                </c:pt>
                <c:pt idx="3">
                  <c:v>5.8547200000000004</c:v>
                </c:pt>
                <c:pt idx="4">
                  <c:v>9.4300599999999992</c:v>
                </c:pt>
                <c:pt idx="5">
                  <c:v>7.8836300000000001</c:v>
                </c:pt>
                <c:pt idx="6">
                  <c:v>13.035500000000001</c:v>
                </c:pt>
                <c:pt idx="7">
                  <c:v>17.3491</c:v>
                </c:pt>
                <c:pt idx="8">
                  <c:v>15.9488</c:v>
                </c:pt>
                <c:pt idx="9">
                  <c:v>14.0786</c:v>
                </c:pt>
                <c:pt idx="10">
                  <c:v>18.64</c:v>
                </c:pt>
                <c:pt idx="11">
                  <c:v>17.725899999999999</c:v>
                </c:pt>
                <c:pt idx="12">
                  <c:v>16.404800000000002</c:v>
                </c:pt>
                <c:pt idx="13">
                  <c:v>15.1518</c:v>
                </c:pt>
                <c:pt idx="14">
                  <c:v>17.799900000000001</c:v>
                </c:pt>
                <c:pt idx="15">
                  <c:v>9.6485199999999995</c:v>
                </c:pt>
                <c:pt idx="16">
                  <c:v>13.8126</c:v>
                </c:pt>
                <c:pt idx="17">
                  <c:v>15.4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285238784"/>
        <c:axId val="285240320"/>
        <c:axId val="0"/>
      </c:bar3DChart>
      <c:catAx>
        <c:axId val="285238784"/>
        <c:scaling>
          <c:orientation val="minMax"/>
        </c:scaling>
        <c:delete val="0"/>
        <c:axPos val="l"/>
        <c:majorTickMark val="out"/>
        <c:minorTickMark val="none"/>
        <c:tickLblPos val="nextTo"/>
        <c:crossAx val="285240320"/>
        <c:crosses val="autoZero"/>
        <c:auto val="1"/>
        <c:lblAlgn val="ctr"/>
        <c:lblOffset val="100"/>
        <c:noMultiLvlLbl val="0"/>
      </c:catAx>
      <c:valAx>
        <c:axId val="285240320"/>
        <c:scaling>
          <c:orientation val="minMax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crossAx val="285238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C4217-F8F6-4C16-9EE6-59A47D357756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57400" y="685800"/>
            <a:ext cx="27432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9B7B49-07F9-4949-BAB6-15A1CC5F1D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1722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ure 1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9B7B49-07F9-4949-BAB6-15A1CC5F1D6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68494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ure</a:t>
            </a:r>
            <a:r>
              <a:rPr lang="en-US" altLang="zh-CN" baseline="0" dirty="0" smtClean="0"/>
              <a:t> 2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9B7B49-07F9-4949-BAB6-15A1CC5F1D6D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501640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ure 3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9B7B49-07F9-4949-BAB6-15A1CC5F1D6D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3380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ure</a:t>
            </a:r>
            <a:r>
              <a:rPr lang="en-US" altLang="zh-CN" baseline="0" dirty="0" smtClean="0"/>
              <a:t> 4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9B7B49-07F9-4949-BAB6-15A1CC5F1D6D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613874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ure 5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9B7B49-07F9-4949-BAB6-15A1CC5F1D6D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365297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Supplementary Figure 1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9B7B49-07F9-4949-BAB6-15A1CC5F1D6D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05880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64157" y="4473902"/>
            <a:ext cx="9793763" cy="308705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728316" y="8161020"/>
            <a:ext cx="8065453" cy="36804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353503" y="576749"/>
            <a:ext cx="2592468" cy="12288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76108" y="576749"/>
            <a:ext cx="7585365" cy="12288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10165" y="9254499"/>
            <a:ext cx="9793763" cy="286035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10165" y="6104098"/>
            <a:ext cx="9793763" cy="315039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76104" y="3360430"/>
            <a:ext cx="5088916" cy="950452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857055" y="3360430"/>
            <a:ext cx="5088916" cy="950452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76107" y="3223737"/>
            <a:ext cx="5090918" cy="13435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76107" y="4567237"/>
            <a:ext cx="5090918" cy="829770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853056" y="3223737"/>
            <a:ext cx="5092918" cy="13435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853056" y="4567237"/>
            <a:ext cx="5092918" cy="829770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76104" y="573405"/>
            <a:ext cx="3790684" cy="244030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504813" y="573415"/>
            <a:ext cx="6441159" cy="1229153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76104" y="3013717"/>
            <a:ext cx="3790684" cy="985123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258412" y="10081260"/>
            <a:ext cx="6913245" cy="1190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258412" y="1286828"/>
            <a:ext cx="6913245" cy="864108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258412" y="11271410"/>
            <a:ext cx="6913245" cy="169021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76105" y="576740"/>
            <a:ext cx="10369867" cy="24003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76105" y="3360430"/>
            <a:ext cx="10369867" cy="950452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76104" y="13348344"/>
            <a:ext cx="2688484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5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936710" y="13348344"/>
            <a:ext cx="3648658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257487" y="13348344"/>
            <a:ext cx="2688484" cy="76676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jpeg"/><Relationship Id="rId10" Type="http://schemas.openxmlformats.org/officeDocument/2006/relationships/image" Target="../media/image8.tiff"/><Relationship Id="rId4" Type="http://schemas.openxmlformats.org/officeDocument/2006/relationships/image" Target="../media/image2.jpeg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Jpeg"/><Relationship Id="rId4" Type="http://schemas.openxmlformats.org/officeDocument/2006/relationships/image" Target="../media/image2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2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3.png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18" Type="http://schemas.openxmlformats.org/officeDocument/2006/relationships/image" Target="../media/image40.png"/><Relationship Id="rId26" Type="http://schemas.openxmlformats.org/officeDocument/2006/relationships/image" Target="../media/image48.png"/><Relationship Id="rId3" Type="http://schemas.openxmlformats.org/officeDocument/2006/relationships/image" Target="../media/image25.png"/><Relationship Id="rId21" Type="http://schemas.openxmlformats.org/officeDocument/2006/relationships/image" Target="../media/image43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17" Type="http://schemas.openxmlformats.org/officeDocument/2006/relationships/image" Target="../media/image39.png"/><Relationship Id="rId25" Type="http://schemas.openxmlformats.org/officeDocument/2006/relationships/image" Target="../media/image47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38.png"/><Relationship Id="rId20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24" Type="http://schemas.openxmlformats.org/officeDocument/2006/relationships/image" Target="../media/image46.png"/><Relationship Id="rId5" Type="http://schemas.openxmlformats.org/officeDocument/2006/relationships/image" Target="../media/image27.png"/><Relationship Id="rId15" Type="http://schemas.openxmlformats.org/officeDocument/2006/relationships/image" Target="../media/image37.png"/><Relationship Id="rId23" Type="http://schemas.openxmlformats.org/officeDocument/2006/relationships/image" Target="../media/image45.png"/><Relationship Id="rId28" Type="http://schemas.openxmlformats.org/officeDocument/2006/relationships/image" Target="../media/image50.png"/><Relationship Id="rId10" Type="http://schemas.openxmlformats.org/officeDocument/2006/relationships/image" Target="../media/image32.png"/><Relationship Id="rId19" Type="http://schemas.openxmlformats.org/officeDocument/2006/relationships/image" Target="../media/image41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6.png"/><Relationship Id="rId22" Type="http://schemas.openxmlformats.org/officeDocument/2006/relationships/image" Target="../media/image44.png"/><Relationship Id="rId27" Type="http://schemas.openxmlformats.org/officeDocument/2006/relationships/image" Target="../media/image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346" y="648172"/>
            <a:ext cx="1350000" cy="180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9037" y="648172"/>
            <a:ext cx="1350000" cy="180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5586" y="628221"/>
            <a:ext cx="1350000" cy="180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018" y="3024436"/>
            <a:ext cx="1438656" cy="123444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9037" y="3018340"/>
            <a:ext cx="1438656" cy="1240536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9586" y="3024436"/>
            <a:ext cx="1417500" cy="1242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904" y="5017068"/>
            <a:ext cx="1438656" cy="1475232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0947" y="5011032"/>
            <a:ext cx="1444752" cy="1438656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1258" y="4994388"/>
            <a:ext cx="1438656" cy="144780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81455" y="2670050"/>
            <a:ext cx="677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B</a:t>
            </a:r>
            <a:endParaRPr lang="zh-CN" altLang="en-US" sz="16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81455" y="453634"/>
            <a:ext cx="677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</a:t>
            </a:r>
            <a:endParaRPr lang="zh-CN" altLang="en-US" sz="16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1455" y="4655834"/>
            <a:ext cx="6773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</a:t>
            </a:r>
            <a:endParaRPr lang="zh-CN" altLang="en-US" sz="16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6298596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083" y="0"/>
            <a:ext cx="11875907" cy="14356325"/>
            <a:chOff x="2083" y="0"/>
            <a:chExt cx="11875907" cy="14356325"/>
          </a:xfrm>
        </p:grpSpPr>
        <p:grpSp>
          <p:nvGrpSpPr>
            <p:cNvPr id="12" name="组合 11"/>
            <p:cNvGrpSpPr/>
            <p:nvPr/>
          </p:nvGrpSpPr>
          <p:grpSpPr>
            <a:xfrm>
              <a:off x="243612" y="3153342"/>
              <a:ext cx="11347590" cy="11202983"/>
              <a:chOff x="390111" y="269614"/>
              <a:chExt cx="11347590" cy="11202983"/>
            </a:xfrm>
          </p:grpSpPr>
          <p:pic>
            <p:nvPicPr>
              <p:cNvPr id="4108" name="Picture 1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307" r="33787"/>
              <a:stretch/>
            </p:blipFill>
            <p:spPr bwMode="auto">
              <a:xfrm>
                <a:off x="414826" y="535184"/>
                <a:ext cx="5057775" cy="22574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10" name="Picture 14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713" t="-614" r="39850" b="420"/>
              <a:stretch/>
            </p:blipFill>
            <p:spPr bwMode="auto">
              <a:xfrm>
                <a:off x="390111" y="3425709"/>
                <a:ext cx="5150881" cy="22713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12" name="Picture 16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085" t="-11393" r="35790" b="1"/>
              <a:stretch/>
            </p:blipFill>
            <p:spPr bwMode="auto">
              <a:xfrm>
                <a:off x="6412922" y="269614"/>
                <a:ext cx="5093406" cy="2514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13" name="Picture 17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963" t="-2895" r="39955" b="1"/>
              <a:stretch/>
            </p:blipFill>
            <p:spPr bwMode="auto">
              <a:xfrm>
                <a:off x="6412922" y="3355572"/>
                <a:ext cx="5085707" cy="23325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14" name="Picture 18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180" t="-907" r="29726" b="-1"/>
              <a:stretch/>
            </p:blipFill>
            <p:spPr bwMode="auto">
              <a:xfrm>
                <a:off x="425413" y="6307412"/>
                <a:ext cx="5088314" cy="228750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15" name="Picture 19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341" t="-156" r="23539"/>
              <a:stretch/>
            </p:blipFill>
            <p:spPr bwMode="auto">
              <a:xfrm>
                <a:off x="6365653" y="6307412"/>
                <a:ext cx="5092618" cy="227048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16" name="Picture 20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248" t="3453" r="36480" b="963"/>
              <a:stretch/>
            </p:blipFill>
            <p:spPr bwMode="auto">
              <a:xfrm>
                <a:off x="487238" y="9305292"/>
                <a:ext cx="5119155" cy="21577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18" name="Picture 22"/>
              <p:cNvPicPr>
                <a:picLocks noChangeAspect="1" noChangeArrowheads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845" t="-104" r="43959"/>
              <a:stretch/>
            </p:blipFill>
            <p:spPr bwMode="auto">
              <a:xfrm>
                <a:off x="6306115" y="9212843"/>
                <a:ext cx="5108286" cy="225975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6" name="矩形 25"/>
              <p:cNvSpPr/>
              <p:nvPr/>
            </p:nvSpPr>
            <p:spPr>
              <a:xfrm>
                <a:off x="432707" y="517204"/>
                <a:ext cx="5108286" cy="22517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6365651" y="517204"/>
                <a:ext cx="5108286" cy="22517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405441" y="3425709"/>
                <a:ext cx="5108286" cy="22517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9" name="矩形 28"/>
              <p:cNvSpPr/>
              <p:nvPr/>
            </p:nvSpPr>
            <p:spPr>
              <a:xfrm>
                <a:off x="6365651" y="3425709"/>
                <a:ext cx="5108286" cy="22517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1" name="矩形 30"/>
              <p:cNvSpPr/>
              <p:nvPr/>
            </p:nvSpPr>
            <p:spPr>
              <a:xfrm>
                <a:off x="6349984" y="6307412"/>
                <a:ext cx="5108286" cy="22517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2" name="矩形 31"/>
              <p:cNvSpPr/>
              <p:nvPr/>
            </p:nvSpPr>
            <p:spPr>
              <a:xfrm>
                <a:off x="487238" y="9194419"/>
                <a:ext cx="5108286" cy="22517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3" name="矩形 32"/>
              <p:cNvSpPr/>
              <p:nvPr/>
            </p:nvSpPr>
            <p:spPr>
              <a:xfrm>
                <a:off x="6306115" y="9197023"/>
                <a:ext cx="5108286" cy="22517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6" name="矩形 35"/>
              <p:cNvSpPr/>
              <p:nvPr/>
            </p:nvSpPr>
            <p:spPr>
              <a:xfrm>
                <a:off x="425413" y="6325957"/>
                <a:ext cx="5108286" cy="22517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8332263" y="618111"/>
                <a:ext cx="1720066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393C</a:t>
                </a:r>
                <a:r>
                  <a:rPr lang="zh-CN" altLang="en-US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＞</a:t>
                </a:r>
                <a:r>
                  <a:rPr lang="en-US" altLang="zh-CN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A</a:t>
                </a:r>
                <a:endParaRPr lang="zh-CN" altLang="en-US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355599" y="3500859"/>
                <a:ext cx="340543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428delT</a:t>
                </a:r>
                <a:endParaRPr lang="zh-CN" altLang="en-US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8332263" y="3500859"/>
                <a:ext cx="340543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457insCC</a:t>
                </a:r>
                <a:endParaRPr lang="zh-CN" altLang="en-US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cxnSp>
            <p:nvCxnSpPr>
              <p:cNvPr id="49" name="直接箭头连接符 48"/>
              <p:cNvCxnSpPr/>
              <p:nvPr/>
            </p:nvCxnSpPr>
            <p:spPr>
              <a:xfrm>
                <a:off x="2888184" y="6731207"/>
                <a:ext cx="0" cy="46238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>
                <a:off x="2430983" y="6382196"/>
                <a:ext cx="1702719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601delC</a:t>
                </a:r>
                <a:endParaRPr lang="zh-CN" altLang="en-US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8332263" y="6382196"/>
                <a:ext cx="340543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716G&gt;C</a:t>
                </a:r>
                <a:endParaRPr lang="zh-CN" altLang="en-US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2221450" y="9305292"/>
                <a:ext cx="340543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889A&gt;G</a:t>
                </a:r>
                <a:endParaRPr lang="zh-CN" altLang="en-US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8332263" y="9305292"/>
                <a:ext cx="3405438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930delG</a:t>
                </a:r>
                <a:endParaRPr lang="zh-CN" altLang="en-US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2242508" y="618111"/>
                <a:ext cx="1720066" cy="369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358G&gt;T</a:t>
                </a:r>
                <a:endParaRPr lang="zh-CN" altLang="en-US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cxnSp>
            <p:nvCxnSpPr>
              <p:cNvPr id="57" name="直接箭头连接符 56"/>
              <p:cNvCxnSpPr/>
              <p:nvPr/>
            </p:nvCxnSpPr>
            <p:spPr>
              <a:xfrm>
                <a:off x="2888184" y="1028082"/>
                <a:ext cx="0" cy="46238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箭头连接符 57"/>
              <p:cNvCxnSpPr/>
              <p:nvPr/>
            </p:nvCxnSpPr>
            <p:spPr>
              <a:xfrm>
                <a:off x="8988254" y="1028082"/>
                <a:ext cx="0" cy="46238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接箭头连接符 58"/>
              <p:cNvCxnSpPr/>
              <p:nvPr/>
            </p:nvCxnSpPr>
            <p:spPr>
              <a:xfrm>
                <a:off x="2888184" y="3960540"/>
                <a:ext cx="0" cy="46238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接箭头连接符 59"/>
              <p:cNvCxnSpPr/>
              <p:nvPr/>
            </p:nvCxnSpPr>
            <p:spPr>
              <a:xfrm>
                <a:off x="8988254" y="3960540"/>
                <a:ext cx="0" cy="46238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箭头连接符 60"/>
              <p:cNvCxnSpPr/>
              <p:nvPr/>
            </p:nvCxnSpPr>
            <p:spPr>
              <a:xfrm>
                <a:off x="8988254" y="6731207"/>
                <a:ext cx="0" cy="46238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箭头连接符 61"/>
              <p:cNvCxnSpPr/>
              <p:nvPr/>
            </p:nvCxnSpPr>
            <p:spPr>
              <a:xfrm>
                <a:off x="2888184" y="9690843"/>
                <a:ext cx="0" cy="46238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箭头连接符 62"/>
              <p:cNvCxnSpPr/>
              <p:nvPr/>
            </p:nvCxnSpPr>
            <p:spPr>
              <a:xfrm>
                <a:off x="8988254" y="9690843"/>
                <a:ext cx="0" cy="462385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0" name="组合 109"/>
            <p:cNvGrpSpPr/>
            <p:nvPr/>
          </p:nvGrpSpPr>
          <p:grpSpPr>
            <a:xfrm>
              <a:off x="275143" y="42339"/>
              <a:ext cx="11602847" cy="2748676"/>
              <a:chOff x="206863" y="933226"/>
              <a:chExt cx="11602847" cy="2748676"/>
            </a:xfrm>
          </p:grpSpPr>
          <p:cxnSp>
            <p:nvCxnSpPr>
              <p:cNvPr id="111" name="直接连接符 110"/>
              <p:cNvCxnSpPr/>
              <p:nvPr/>
            </p:nvCxnSpPr>
            <p:spPr>
              <a:xfrm>
                <a:off x="206863" y="2840361"/>
                <a:ext cx="11170799" cy="12576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矩形 111"/>
              <p:cNvSpPr/>
              <p:nvPr/>
            </p:nvSpPr>
            <p:spPr>
              <a:xfrm>
                <a:off x="351277" y="2624337"/>
                <a:ext cx="1462940" cy="432048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3" name="矩形 112"/>
              <p:cNvSpPr/>
              <p:nvPr/>
            </p:nvSpPr>
            <p:spPr>
              <a:xfrm>
                <a:off x="2905751" y="2624337"/>
                <a:ext cx="432000" cy="432048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4" name="矩形 113"/>
              <p:cNvSpPr/>
              <p:nvPr/>
            </p:nvSpPr>
            <p:spPr>
              <a:xfrm>
                <a:off x="3883639" y="2624337"/>
                <a:ext cx="432048" cy="432048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115" name="Picture 14"/>
              <p:cNvPicPr>
                <a:picLocks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904292" y="2624337"/>
                <a:ext cx="288000" cy="4572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6" name="矩形 115"/>
              <p:cNvSpPr>
                <a:spLocks/>
              </p:cNvSpPr>
              <p:nvPr/>
            </p:nvSpPr>
            <p:spPr>
              <a:xfrm>
                <a:off x="10301664" y="2624337"/>
                <a:ext cx="864000" cy="432048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652197" y="1983474"/>
                <a:ext cx="10321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208G&gt;T</a:t>
                </a:r>
                <a:endParaRPr lang="zh-CN" altLang="en-US" sz="14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3532517" y="933226"/>
                <a:ext cx="1180182" cy="954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393C&gt;A</a:t>
                </a:r>
              </a:p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396C&gt;G</a:t>
                </a:r>
              </a:p>
              <a:p>
                <a:r>
                  <a:rPr lang="en-US" altLang="zh-CN" sz="1400" dirty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428delT</a:t>
                </a:r>
                <a:endParaRPr lang="en-US" altLang="zh-CN" sz="1400" dirty="0" smtClean="0">
                  <a:solidFill>
                    <a:srgbClr val="FF0000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r>
                  <a:rPr lang="en-US" altLang="zh-CN" sz="1400" dirty="0" smtClean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457insCC</a:t>
                </a:r>
                <a:endParaRPr lang="en-US" altLang="zh-CN" sz="1400" dirty="0">
                  <a:solidFill>
                    <a:srgbClr val="FF0000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4756653" y="1148669"/>
                <a:ext cx="1262680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527A&gt;G</a:t>
                </a:r>
                <a:endParaRPr lang="en-US" altLang="zh-CN" sz="14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r>
                  <a:rPr lang="en-US" altLang="zh-CN" sz="1400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551T&gt;C</a:t>
                </a:r>
                <a:endParaRPr lang="en-US" altLang="zh-CN" sz="14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  <a:p>
                <a:r>
                  <a:rPr lang="en-US" altLang="zh-CN" sz="1400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580G&gt;A</a:t>
                </a:r>
                <a:endParaRPr lang="zh-CN" altLang="en-US" sz="14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5620749" y="1768031"/>
                <a:ext cx="104957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601delC</a:t>
                </a:r>
              </a:p>
              <a:p>
                <a:r>
                  <a:rPr lang="en-US" altLang="zh-CN" sz="1400" dirty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716G&gt;C </a:t>
                </a:r>
                <a:endParaRPr lang="zh-CN" altLang="en-US" sz="1400" dirty="0">
                  <a:solidFill>
                    <a:srgbClr val="FF0000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6628861" y="933226"/>
                <a:ext cx="1399194" cy="954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738C&gt;G</a:t>
                </a:r>
              </a:p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752G&gt;A</a:t>
                </a:r>
              </a:p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842insC(2)</a:t>
                </a:r>
              </a:p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842delC</a:t>
                </a: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7733317" y="1983474"/>
                <a:ext cx="108025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889A&gt;G</a:t>
                </a:r>
                <a:endParaRPr lang="zh-CN" altLang="en-US" sz="1400" dirty="0">
                  <a:solidFill>
                    <a:srgbClr val="FF0000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8770067" y="1148669"/>
                <a:ext cx="1819233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923G&gt;A</a:t>
                </a:r>
              </a:p>
              <a:p>
                <a:r>
                  <a:rPr lang="en-US" altLang="zh-CN" sz="1400" dirty="0" smtClean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930delG</a:t>
                </a:r>
              </a:p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1010_1011delTG</a:t>
                </a:r>
                <a:endParaRPr lang="en-US" altLang="zh-CN" sz="14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cxnSp>
            <p:nvCxnSpPr>
              <p:cNvPr id="124" name="直接连接符 123"/>
              <p:cNvCxnSpPr/>
              <p:nvPr/>
            </p:nvCxnSpPr>
            <p:spPr>
              <a:xfrm>
                <a:off x="1082747" y="2250173"/>
                <a:ext cx="0" cy="3600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接连接符 124"/>
              <p:cNvCxnSpPr/>
              <p:nvPr/>
            </p:nvCxnSpPr>
            <p:spPr>
              <a:xfrm>
                <a:off x="4099663" y="1845745"/>
                <a:ext cx="0" cy="764468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接连接符 125"/>
              <p:cNvCxnSpPr/>
              <p:nvPr/>
            </p:nvCxnSpPr>
            <p:spPr>
              <a:xfrm>
                <a:off x="6029222" y="2250173"/>
                <a:ext cx="0" cy="3600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直接连接符 126"/>
              <p:cNvCxnSpPr/>
              <p:nvPr/>
            </p:nvCxnSpPr>
            <p:spPr>
              <a:xfrm>
                <a:off x="8048292" y="2250173"/>
                <a:ext cx="0" cy="3600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直接连接符 127"/>
              <p:cNvCxnSpPr/>
              <p:nvPr/>
            </p:nvCxnSpPr>
            <p:spPr>
              <a:xfrm>
                <a:off x="5238109" y="1845745"/>
                <a:ext cx="0" cy="764468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接连接符 128"/>
              <p:cNvCxnSpPr/>
              <p:nvPr/>
            </p:nvCxnSpPr>
            <p:spPr>
              <a:xfrm>
                <a:off x="7057181" y="1845745"/>
                <a:ext cx="0" cy="764468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直接连接符 129"/>
              <p:cNvCxnSpPr/>
              <p:nvPr/>
            </p:nvCxnSpPr>
            <p:spPr>
              <a:xfrm>
                <a:off x="9181410" y="1845745"/>
                <a:ext cx="0" cy="764468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TextBox 130"/>
              <p:cNvSpPr txBox="1"/>
              <p:nvPr/>
            </p:nvSpPr>
            <p:spPr>
              <a:xfrm>
                <a:off x="779813" y="3374125"/>
                <a:ext cx="11663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Del exon1(3)</a:t>
                </a:r>
                <a:endParaRPr lang="zh-CN" altLang="en-US" sz="14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3121751" y="3374125"/>
                <a:ext cx="28984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Del </a:t>
                </a:r>
                <a:r>
                  <a:rPr lang="en-US" altLang="zh-CN" sz="140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exon </a:t>
                </a:r>
                <a:r>
                  <a:rPr lang="en-US" altLang="zh-CN" sz="140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2-3(2) </a:t>
                </a:r>
                <a:endParaRPr lang="zh-CN" altLang="en-US" sz="14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8706074" y="3374125"/>
                <a:ext cx="310363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Del </a:t>
                </a:r>
                <a:r>
                  <a:rPr lang="en-US" altLang="zh-CN" sz="1400" dirty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exon 8 </a:t>
                </a:r>
                <a:endParaRPr lang="zh-CN" altLang="en-US" sz="14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cxnSp>
            <p:nvCxnSpPr>
              <p:cNvPr id="134" name="直接连接符 133"/>
              <p:cNvCxnSpPr/>
              <p:nvPr/>
            </p:nvCxnSpPr>
            <p:spPr>
              <a:xfrm>
                <a:off x="335859" y="3068960"/>
                <a:ext cx="746888" cy="305165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接连接符 134"/>
              <p:cNvCxnSpPr/>
              <p:nvPr/>
            </p:nvCxnSpPr>
            <p:spPr>
              <a:xfrm>
                <a:off x="2952725" y="3051827"/>
                <a:ext cx="647658" cy="307196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接连接符 135"/>
              <p:cNvCxnSpPr/>
              <p:nvPr/>
            </p:nvCxnSpPr>
            <p:spPr>
              <a:xfrm flipV="1">
                <a:off x="1126017" y="3068960"/>
                <a:ext cx="685972" cy="305165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直接连接符 136"/>
              <p:cNvCxnSpPr/>
              <p:nvPr/>
            </p:nvCxnSpPr>
            <p:spPr>
              <a:xfrm flipV="1">
                <a:off x="3672805" y="3052337"/>
                <a:ext cx="642882" cy="306686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直接连接符 137"/>
              <p:cNvCxnSpPr/>
              <p:nvPr/>
            </p:nvCxnSpPr>
            <p:spPr>
              <a:xfrm>
                <a:off x="8785372" y="3068960"/>
                <a:ext cx="396038" cy="297375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接连接符 138"/>
              <p:cNvCxnSpPr/>
              <p:nvPr/>
            </p:nvCxnSpPr>
            <p:spPr>
              <a:xfrm flipV="1">
                <a:off x="9228840" y="3068960"/>
                <a:ext cx="298590" cy="305165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TextBox 139"/>
              <p:cNvSpPr txBox="1"/>
              <p:nvPr/>
            </p:nvSpPr>
            <p:spPr>
              <a:xfrm>
                <a:off x="2524405" y="1983474"/>
                <a:ext cx="11641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.</a:t>
                </a:r>
                <a:r>
                  <a:rPr lang="en-US" altLang="zh-CN" sz="1400" dirty="0" smtClean="0">
                    <a:solidFill>
                      <a:srgbClr val="FF0000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358G&gt;T</a:t>
                </a:r>
                <a:endParaRPr lang="zh-CN" altLang="en-US" sz="1400" dirty="0">
                  <a:solidFill>
                    <a:srgbClr val="FF0000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cxnSp>
            <p:nvCxnSpPr>
              <p:cNvPr id="141" name="直接连接符 140"/>
              <p:cNvCxnSpPr/>
              <p:nvPr/>
            </p:nvCxnSpPr>
            <p:spPr>
              <a:xfrm>
                <a:off x="3121751" y="2250173"/>
                <a:ext cx="0" cy="360040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矩形 141"/>
              <p:cNvSpPr/>
              <p:nvPr/>
            </p:nvSpPr>
            <p:spPr>
              <a:xfrm>
                <a:off x="4907249" y="2624337"/>
                <a:ext cx="651258" cy="432048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3" name="矩形 142"/>
              <p:cNvSpPr/>
              <p:nvPr/>
            </p:nvSpPr>
            <p:spPr>
              <a:xfrm>
                <a:off x="5713845" y="2624337"/>
                <a:ext cx="623255" cy="432048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4" name="矩形 143"/>
              <p:cNvSpPr/>
              <p:nvPr/>
            </p:nvSpPr>
            <p:spPr>
              <a:xfrm>
                <a:off x="6763420" y="2624337"/>
                <a:ext cx="555436" cy="432048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5" name="矩形 144"/>
              <p:cNvSpPr/>
              <p:nvPr/>
            </p:nvSpPr>
            <p:spPr>
              <a:xfrm>
                <a:off x="8813573" y="2624337"/>
                <a:ext cx="730638" cy="432048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867973" y="2635672"/>
                <a:ext cx="51608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1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2905751" y="2635672"/>
                <a:ext cx="6946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2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3883639" y="2635672"/>
                <a:ext cx="5921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3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4980064" y="2635672"/>
                <a:ext cx="7337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4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5792262" y="2635672"/>
                <a:ext cx="856836" cy="3705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5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6783093" y="2635672"/>
                <a:ext cx="7061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6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7733318" y="2635672"/>
                <a:ext cx="68706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 7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8923366" y="2635672"/>
                <a:ext cx="51608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8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10475620" y="2635672"/>
                <a:ext cx="51608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9</a:t>
                </a:r>
                <a:endParaRPr lang="zh-CN" altLang="en-US" b="1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2083" y="0"/>
              <a:ext cx="6773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</a:t>
              </a:r>
              <a:endParaRPr lang="zh-CN" altLang="en-US" sz="16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2083" y="3029299"/>
              <a:ext cx="6773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B</a:t>
              </a:r>
              <a:endParaRPr lang="zh-CN" altLang="en-US" sz="16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18735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1" t="7151" r="3269" b="9882"/>
          <a:stretch/>
        </p:blipFill>
        <p:spPr>
          <a:xfrm>
            <a:off x="288429" y="241262"/>
            <a:ext cx="5760000" cy="320105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7" t="7473" r="3452" b="8086"/>
          <a:stretch/>
        </p:blipFill>
        <p:spPr>
          <a:xfrm>
            <a:off x="288429" y="4005049"/>
            <a:ext cx="5760000" cy="328119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9" t="7104" r="3452" b="9745"/>
          <a:stretch/>
        </p:blipFill>
        <p:spPr>
          <a:xfrm>
            <a:off x="288429" y="7848971"/>
            <a:ext cx="5760000" cy="324056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2405" y="83141"/>
            <a:ext cx="365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2405" y="7643981"/>
            <a:ext cx="365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2405" y="3827557"/>
            <a:ext cx="365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B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84364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图表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1126788"/>
              </p:ext>
            </p:extLst>
          </p:nvPr>
        </p:nvGraphicFramePr>
        <p:xfrm>
          <a:off x="882159" y="400050"/>
          <a:ext cx="9757757" cy="1360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0351884" y="13444682"/>
            <a:ext cx="1385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(FPKM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567301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585" t="9556" r="19145" b="4944"/>
          <a:stretch/>
        </p:blipFill>
        <p:spPr bwMode="auto">
          <a:xfrm>
            <a:off x="1007939" y="199321"/>
            <a:ext cx="4278072" cy="3672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2" name="组合 11"/>
          <p:cNvGrpSpPr/>
          <p:nvPr/>
        </p:nvGrpSpPr>
        <p:grpSpPr>
          <a:xfrm>
            <a:off x="5111806" y="73500"/>
            <a:ext cx="1657343" cy="569808"/>
            <a:chOff x="5111806" y="73500"/>
            <a:chExt cx="1657343" cy="569808"/>
          </a:xfrm>
        </p:grpSpPr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clrChange>
                <a:clrFrom>
                  <a:srgbClr val="F0F0F0"/>
                </a:clrFrom>
                <a:clrTo>
                  <a:srgbClr val="F0F0F0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286" t="19896" r="13727" b="76570"/>
            <a:stretch/>
          </p:blipFill>
          <p:spPr bwMode="auto">
            <a:xfrm>
              <a:off x="5111806" y="123417"/>
              <a:ext cx="349549" cy="1518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5461355" y="73500"/>
              <a:ext cx="13077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Missense mutation</a:t>
              </a:r>
              <a:endParaRPr lang="zh-CN" altLang="en-US" sz="10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pic>
          <p:nvPicPr>
            <p:cNvPr id="8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clrChange>
                <a:clrFrom>
                  <a:srgbClr val="F0F0F0"/>
                </a:clrFrom>
                <a:clrTo>
                  <a:srgbClr val="F0F0F0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286" t="23430" r="13727" b="73036"/>
            <a:stretch/>
          </p:blipFill>
          <p:spPr bwMode="auto">
            <a:xfrm>
              <a:off x="5111806" y="459684"/>
              <a:ext cx="349549" cy="1518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5461355" y="397087"/>
              <a:ext cx="10917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Null  mutation</a:t>
              </a:r>
              <a:endParaRPr lang="zh-CN" altLang="en-US" sz="10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872733" y="3854518"/>
            <a:ext cx="3096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ge of  first detection of GI </a:t>
            </a:r>
            <a:r>
              <a:rPr lang="en-US" altLang="zh-CN" sz="12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olyps (years)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85230" y="1296244"/>
            <a:ext cx="369332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umulative rate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02507" y="123417"/>
            <a:ext cx="365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grpSp>
        <p:nvGrpSpPr>
          <p:cNvPr id="32" name="组合 31"/>
          <p:cNvGrpSpPr/>
          <p:nvPr/>
        </p:nvGrpSpPr>
        <p:grpSpPr>
          <a:xfrm>
            <a:off x="502507" y="4089514"/>
            <a:ext cx="6410657" cy="4137689"/>
            <a:chOff x="502507" y="3872162"/>
            <a:chExt cx="6410657" cy="4137689"/>
          </a:xfrm>
        </p:grpSpPr>
        <p:pic>
          <p:nvPicPr>
            <p:cNvPr id="11" name="Picture 2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48" t="12951" r="17973" b="6087"/>
            <a:stretch/>
          </p:blipFill>
          <p:spPr bwMode="auto">
            <a:xfrm>
              <a:off x="1007939" y="4131517"/>
              <a:ext cx="4193628" cy="36013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3" name="组合 12"/>
            <p:cNvGrpSpPr/>
            <p:nvPr/>
          </p:nvGrpSpPr>
          <p:grpSpPr>
            <a:xfrm>
              <a:off x="5111806" y="3872162"/>
              <a:ext cx="1801358" cy="600586"/>
              <a:chOff x="5111806" y="73500"/>
              <a:chExt cx="1801358" cy="600586"/>
            </a:xfrm>
          </p:grpSpPr>
          <p:pic>
            <p:nvPicPr>
              <p:cNvPr id="14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clrChange>
                  <a:clrFrom>
                    <a:srgbClr val="F0F0F0"/>
                  </a:clrFrom>
                  <a:clrTo>
                    <a:srgbClr val="F0F0F0">
                      <a:alpha val="0"/>
                    </a:srgbClr>
                  </a:clrTo>
                </a:clrChang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4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286" t="19896" r="13727" b="76570"/>
              <a:stretch/>
            </p:blipFill>
            <p:spPr bwMode="auto">
              <a:xfrm>
                <a:off x="5111806" y="123417"/>
                <a:ext cx="349549" cy="1518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5461355" y="73500"/>
                <a:ext cx="14518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Missense</a:t>
                </a:r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</a:t>
                </a:r>
                <a:r>
                  <a:rPr lang="en-US" altLang="zh-CN" sz="10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mutation</a:t>
                </a:r>
                <a:endParaRPr lang="zh-CN" altLang="en-US" sz="10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pic>
            <p:nvPicPr>
              <p:cNvPr id="16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clrChange>
                  <a:clrFrom>
                    <a:srgbClr val="F0F0F0"/>
                  </a:clrFrom>
                  <a:clrTo>
                    <a:srgbClr val="F0F0F0">
                      <a:alpha val="0"/>
                    </a:srgbClr>
                  </a:clrTo>
                </a:clrChang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4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286" t="23430" r="13727" b="73036"/>
              <a:stretch/>
            </p:blipFill>
            <p:spPr bwMode="auto">
              <a:xfrm>
                <a:off x="5111806" y="459684"/>
                <a:ext cx="349549" cy="1518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5461355" y="397087"/>
                <a:ext cx="10197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Null</a:t>
                </a:r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 </a:t>
                </a:r>
                <a:r>
                  <a:rPr lang="en-US" altLang="zh-CN" sz="10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mutation</a:t>
                </a:r>
                <a:endParaRPr lang="zh-CN" altLang="en-US" sz="10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sp>
          <p:nvSpPr>
            <p:cNvPr id="18" name="TextBox 17"/>
            <p:cNvSpPr txBox="1"/>
            <p:nvPr/>
          </p:nvSpPr>
          <p:spPr>
            <a:xfrm>
              <a:off x="1348980" y="7732852"/>
              <a:ext cx="38880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ge of first occurrence of intestinal obstruction (years</a:t>
              </a:r>
              <a:r>
                <a: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)</a:t>
              </a:r>
              <a:endParaRPr lang="zh-CN" altLang="en-US" sz="12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85230" y="5184676"/>
              <a:ext cx="369332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Cumulative rate</a:t>
              </a:r>
              <a:endParaRPr lang="zh-CN" altLang="en-US" sz="12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02507" y="3918750"/>
              <a:ext cx="3654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B</a:t>
              </a:r>
              <a:endParaRPr lang="zh-CN" altLang="en-US" sz="12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502507" y="8268638"/>
            <a:ext cx="6266642" cy="4097869"/>
            <a:chOff x="502507" y="7992270"/>
            <a:chExt cx="6266642" cy="4097869"/>
          </a:xfrm>
        </p:grpSpPr>
        <p:pic>
          <p:nvPicPr>
            <p:cNvPr id="20" name="Picture 2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50" t="10000" r="17203" b="7021"/>
            <a:stretch/>
          </p:blipFill>
          <p:spPr bwMode="auto">
            <a:xfrm>
              <a:off x="1007939" y="8137004"/>
              <a:ext cx="4229101" cy="37147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1" name="组合 20"/>
            <p:cNvGrpSpPr/>
            <p:nvPr/>
          </p:nvGrpSpPr>
          <p:grpSpPr>
            <a:xfrm>
              <a:off x="5111806" y="8067545"/>
              <a:ext cx="1657343" cy="600585"/>
              <a:chOff x="5111806" y="73501"/>
              <a:chExt cx="1657343" cy="600585"/>
            </a:xfrm>
          </p:grpSpPr>
          <p:pic>
            <p:nvPicPr>
              <p:cNvPr id="22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clrChange>
                  <a:clrFrom>
                    <a:srgbClr val="F0F0F0"/>
                  </a:clrFrom>
                  <a:clrTo>
                    <a:srgbClr val="F0F0F0">
                      <a:alpha val="0"/>
                    </a:srgbClr>
                  </a:clrTo>
                </a:clrChang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4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286" t="19896" r="13727" b="76570"/>
              <a:stretch/>
            </p:blipFill>
            <p:spPr bwMode="auto">
              <a:xfrm>
                <a:off x="5111806" y="123417"/>
                <a:ext cx="349549" cy="1518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5461354" y="73501"/>
                <a:ext cx="13077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Missense</a:t>
                </a:r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</a:t>
                </a:r>
                <a:r>
                  <a:rPr lang="en-US" altLang="zh-CN" sz="10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mutation</a:t>
                </a:r>
                <a:endParaRPr lang="zh-CN" altLang="en-US" sz="10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pic>
            <p:nvPicPr>
              <p:cNvPr id="24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clrChange>
                  <a:clrFrom>
                    <a:srgbClr val="F0F0F0"/>
                  </a:clrFrom>
                  <a:clrTo>
                    <a:srgbClr val="F0F0F0">
                      <a:alpha val="0"/>
                    </a:srgbClr>
                  </a:clrTo>
                </a:clrChang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4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286" t="23430" r="13727" b="73036"/>
              <a:stretch/>
            </p:blipFill>
            <p:spPr bwMode="auto">
              <a:xfrm>
                <a:off x="5111806" y="459684"/>
                <a:ext cx="349549" cy="1518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5461355" y="397087"/>
                <a:ext cx="10197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Null </a:t>
                </a:r>
                <a:r>
                  <a:rPr lang="en-US" altLang="zh-CN" sz="12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 </a:t>
                </a:r>
                <a:r>
                  <a:rPr lang="en-US" altLang="zh-CN" sz="1000" dirty="0" smtClean="0"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mutation</a:t>
                </a:r>
                <a:endParaRPr lang="zh-CN" altLang="en-US" sz="10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sp>
          <p:nvSpPr>
            <p:cNvPr id="26" name="TextBox 25"/>
            <p:cNvSpPr txBox="1"/>
            <p:nvPr/>
          </p:nvSpPr>
          <p:spPr>
            <a:xfrm>
              <a:off x="685230" y="9217124"/>
              <a:ext cx="369332" cy="14401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Cumulative rate</a:t>
              </a:r>
              <a:endParaRPr lang="zh-CN" altLang="en-US" sz="12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193254" y="11813140"/>
              <a:ext cx="21995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ge of first surgery </a:t>
              </a:r>
              <a:r>
                <a:rPr lang="en-US" altLang="zh-CN" sz="1200" dirty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(years</a:t>
              </a:r>
              <a:r>
                <a:rPr lang="en-US" altLang="zh-CN" sz="12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)</a:t>
              </a:r>
              <a:endParaRPr lang="zh-CN" altLang="en-US" sz="12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02507" y="7992270"/>
              <a:ext cx="3654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C</a:t>
              </a:r>
              <a:endParaRPr lang="zh-CN" altLang="en-US" sz="12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078292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2" y="446379"/>
            <a:ext cx="3456383" cy="13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3" name="TextBox 62"/>
          <p:cNvSpPr txBox="1"/>
          <p:nvPr/>
        </p:nvSpPr>
        <p:spPr>
          <a:xfrm>
            <a:off x="123477" y="172919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672805" y="172919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2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7633245" y="172919"/>
            <a:ext cx="1800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3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23477" y="1794128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4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23477" y="3415337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7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23477" y="5036546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0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23477" y="6657755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3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7633245" y="8400883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8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23477" y="9900172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9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23477" y="11521380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22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672805" y="1794128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5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7633245" y="1794128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6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2758" y="446379"/>
            <a:ext cx="3328080" cy="1162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1" y="1970846"/>
            <a:ext cx="2771762" cy="12734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2" y="1970846"/>
            <a:ext cx="2400171" cy="12322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2759" y="1970846"/>
            <a:ext cx="2934845" cy="13437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2" y="3720292"/>
            <a:ext cx="2339715" cy="9918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3" name="TextBox 82"/>
          <p:cNvSpPr txBox="1"/>
          <p:nvPr/>
        </p:nvSpPr>
        <p:spPr>
          <a:xfrm>
            <a:off x="3672805" y="3415337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8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7633245" y="3415337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9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2" y="3720292"/>
            <a:ext cx="2977197" cy="11763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2758" y="3720292"/>
            <a:ext cx="3378722" cy="10734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8" name="TextBox 87"/>
          <p:cNvSpPr txBox="1"/>
          <p:nvPr/>
        </p:nvSpPr>
        <p:spPr>
          <a:xfrm>
            <a:off x="3672805" y="5036546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1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7633245" y="5036546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2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1" y="5266950"/>
            <a:ext cx="1499342" cy="1387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1" y="5266950"/>
            <a:ext cx="1929910" cy="14154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2759" y="5266950"/>
            <a:ext cx="1765789" cy="11970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3" name="TextBox 92"/>
          <p:cNvSpPr txBox="1"/>
          <p:nvPr/>
        </p:nvSpPr>
        <p:spPr>
          <a:xfrm>
            <a:off x="3672805" y="6657755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4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7633245" y="6657755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5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2" y="7060991"/>
            <a:ext cx="2961383" cy="11100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2" y="7060991"/>
            <a:ext cx="3719877" cy="1025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2" y="446379"/>
            <a:ext cx="1713819" cy="10482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2759" y="7060991"/>
            <a:ext cx="3135065" cy="1119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9" name="TextBox 98"/>
          <p:cNvSpPr txBox="1"/>
          <p:nvPr/>
        </p:nvSpPr>
        <p:spPr>
          <a:xfrm>
            <a:off x="3672805" y="8400883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7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23477" y="8400883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16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1" y="8715566"/>
            <a:ext cx="1868588" cy="10740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1" y="8715567"/>
            <a:ext cx="1574732" cy="9270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2758" y="8715567"/>
            <a:ext cx="3035862" cy="11352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4" name="TextBox 103"/>
          <p:cNvSpPr txBox="1"/>
          <p:nvPr/>
        </p:nvSpPr>
        <p:spPr>
          <a:xfrm>
            <a:off x="3672805" y="9900172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20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633245" y="9900172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21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47" name="Picture 23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1" y="10238053"/>
            <a:ext cx="2686804" cy="12194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1" y="10238053"/>
            <a:ext cx="1747616" cy="10154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9" name="Picture 25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2759" y="10238053"/>
            <a:ext cx="3626911" cy="12257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9" name="TextBox 108"/>
          <p:cNvSpPr txBox="1"/>
          <p:nvPr/>
        </p:nvSpPr>
        <p:spPr>
          <a:xfrm>
            <a:off x="3672805" y="11521380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23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7657221" y="11521380"/>
            <a:ext cx="163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24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23477" y="13076408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25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50" name="Picture 26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2" y="11792224"/>
            <a:ext cx="1353605" cy="766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1" name="Picture 27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1" y="11792223"/>
            <a:ext cx="3869372" cy="11874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2" name="Picture 28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2759" y="11792223"/>
            <a:ext cx="1749357" cy="1009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3" name="Picture 29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062" y="13479998"/>
            <a:ext cx="2269737" cy="13192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4" name="Picture 30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881" y="13479998"/>
            <a:ext cx="2258958" cy="12184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8" name="TextBox 117"/>
          <p:cNvSpPr txBox="1"/>
          <p:nvPr/>
        </p:nvSpPr>
        <p:spPr>
          <a:xfrm>
            <a:off x="3672805" y="13076408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Family 26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161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0</TotalTime>
  <Words>191</Words>
  <Application>Microsoft Office PowerPoint</Application>
  <PresentationFormat>自定义</PresentationFormat>
  <Paragraphs>102</Paragraphs>
  <Slides>6</Slides>
  <Notes>6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48</cp:revision>
  <dcterms:created xsi:type="dcterms:W3CDTF">2019-10-09T12:06:57Z</dcterms:created>
  <dcterms:modified xsi:type="dcterms:W3CDTF">2020-05-01T14:44:52Z</dcterms:modified>
</cp:coreProperties>
</file>